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64" r:id="rId2"/>
    <p:sldId id="5073" r:id="rId3"/>
    <p:sldId id="265" r:id="rId4"/>
    <p:sldId id="5074" r:id="rId5"/>
    <p:sldId id="5075" r:id="rId6"/>
    <p:sldId id="5064" r:id="rId7"/>
    <p:sldId id="1013" r:id="rId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4" d="100"/>
          <a:sy n="104" d="100"/>
        </p:scale>
        <p:origin x="284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靖泽 陈" userId="712ced27423dcabf" providerId="LiveId" clId="{737FA15E-F9CB-4E68-A010-4EFB500CAA5B}"/>
    <pc:docChg chg="delSld">
      <pc:chgData name="靖泽 陈" userId="712ced27423dcabf" providerId="LiveId" clId="{737FA15E-F9CB-4E68-A010-4EFB500CAA5B}" dt="2025-05-29T03:46:56.757" v="7" actId="47"/>
      <pc:docMkLst>
        <pc:docMk/>
      </pc:docMkLst>
      <pc:sldChg chg="del">
        <pc:chgData name="靖泽 陈" userId="712ced27423dcabf" providerId="LiveId" clId="{737FA15E-F9CB-4E68-A010-4EFB500CAA5B}" dt="2025-05-29T03:46:54.151" v="3" actId="47"/>
        <pc:sldMkLst>
          <pc:docMk/>
          <pc:sldMk cId="1511505183" sldId="256"/>
        </pc:sldMkLst>
      </pc:sldChg>
      <pc:sldChg chg="del">
        <pc:chgData name="靖泽 陈" userId="712ced27423dcabf" providerId="LiveId" clId="{737FA15E-F9CB-4E68-A010-4EFB500CAA5B}" dt="2025-05-29T03:46:54.800" v="4" actId="47"/>
        <pc:sldMkLst>
          <pc:docMk/>
          <pc:sldMk cId="4123501545" sldId="257"/>
        </pc:sldMkLst>
      </pc:sldChg>
      <pc:sldChg chg="del">
        <pc:chgData name="靖泽 陈" userId="712ced27423dcabf" providerId="LiveId" clId="{737FA15E-F9CB-4E68-A010-4EFB500CAA5B}" dt="2025-05-29T03:46:56.059" v="6" actId="47"/>
        <pc:sldMkLst>
          <pc:docMk/>
          <pc:sldMk cId="1079109298" sldId="5052"/>
        </pc:sldMkLst>
      </pc:sldChg>
      <pc:sldChg chg="del">
        <pc:chgData name="靖泽 陈" userId="712ced27423dcabf" providerId="LiveId" clId="{737FA15E-F9CB-4E68-A010-4EFB500CAA5B}" dt="2025-05-29T03:46:52.745" v="1" actId="47"/>
        <pc:sldMkLst>
          <pc:docMk/>
          <pc:sldMk cId="1136857576" sldId="5056"/>
        </pc:sldMkLst>
      </pc:sldChg>
      <pc:sldChg chg="del">
        <pc:chgData name="靖泽 陈" userId="712ced27423dcabf" providerId="LiveId" clId="{737FA15E-F9CB-4E68-A010-4EFB500CAA5B}" dt="2025-05-29T03:46:55.435" v="5" actId="47"/>
        <pc:sldMkLst>
          <pc:docMk/>
          <pc:sldMk cId="1039865290" sldId="5058"/>
        </pc:sldMkLst>
      </pc:sldChg>
      <pc:sldChg chg="del">
        <pc:chgData name="靖泽 陈" userId="712ced27423dcabf" providerId="LiveId" clId="{737FA15E-F9CB-4E68-A010-4EFB500CAA5B}" dt="2025-05-29T03:46:56.757" v="7" actId="47"/>
        <pc:sldMkLst>
          <pc:docMk/>
          <pc:sldMk cId="1538386877" sldId="5059"/>
        </pc:sldMkLst>
      </pc:sldChg>
      <pc:sldChg chg="del">
        <pc:chgData name="靖泽 陈" userId="712ced27423dcabf" providerId="LiveId" clId="{737FA15E-F9CB-4E68-A010-4EFB500CAA5B}" dt="2025-05-29T03:46:53.379" v="2" actId="47"/>
        <pc:sldMkLst>
          <pc:docMk/>
          <pc:sldMk cId="2432443626" sldId="5063"/>
        </pc:sldMkLst>
      </pc:sldChg>
      <pc:sldChg chg="del">
        <pc:chgData name="靖泽 陈" userId="712ced27423dcabf" providerId="LiveId" clId="{737FA15E-F9CB-4E68-A010-4EFB500CAA5B}" dt="2025-05-29T03:46:51.985" v="0" actId="47"/>
        <pc:sldMkLst>
          <pc:docMk/>
          <pc:sldMk cId="3519886723" sldId="5076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6FD4695-0795-4930-BD96-F9F5449AAB3F}" type="datetimeFigureOut">
              <a:rPr lang="zh-CN" altLang="en-US" smtClean="0"/>
              <a:t>2025/5/2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9DE2DC4-7CB0-4823-90A0-6D32634870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47486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80530BA-395B-D2B0-EB44-C07FEEF7509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125863EB-07C1-BC0D-B7C7-824593358A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3938F31-5658-56BB-91FE-CBBD13A5C7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FA995-C7D9-4C6C-A9E8-E56122711CA3}" type="datetimeFigureOut">
              <a:rPr lang="zh-CN" altLang="en-US" smtClean="0"/>
              <a:t>2025/5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A3DCC17-556C-97D8-88DA-A1B8CF1207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B8C8395-B046-BD1E-C9B1-2FB47B2365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C5060-3EB4-4F26-B7F8-4A4BC04DB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03463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CDB260C-D612-7E70-6E90-1AEC7A2804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5A325CF-D41E-F5E6-9273-A49EEB04C4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07B2D27-C880-B462-B67E-54504BF0FE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FA995-C7D9-4C6C-A9E8-E56122711CA3}" type="datetimeFigureOut">
              <a:rPr lang="zh-CN" altLang="en-US" smtClean="0"/>
              <a:t>2025/5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46ACD1C-2165-7598-8391-8E9EE202E8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8CD582A-86BB-E854-AE5F-7DD5CAF3CC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C5060-3EB4-4F26-B7F8-4A4BC04DB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27029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DD4921D4-31B1-A6A9-A731-56B377A8AC7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1B404FD-8719-4CF4-113C-C494E49E84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AB25786-8466-3F28-9F82-37B2BF9454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FA995-C7D9-4C6C-A9E8-E56122711CA3}" type="datetimeFigureOut">
              <a:rPr lang="zh-CN" altLang="en-US" smtClean="0"/>
              <a:t>2025/5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6DFA033-E650-0E01-7770-78961CED12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10D55D2-51F5-3D16-9FD5-3B8E135D71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C5060-3EB4-4F26-B7F8-4A4BC04DB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99143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FCB4B6D-5E1C-4C20-EEDB-0C67C29291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F057C72-B533-CE97-BF1E-CD1142C9EB1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6AF876A-C671-059E-2A98-1A09F45FD4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FA995-C7D9-4C6C-A9E8-E56122711CA3}" type="datetimeFigureOut">
              <a:rPr lang="zh-CN" altLang="en-US" smtClean="0"/>
              <a:t>2025/5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A8A3E89-855C-9A29-F44B-8CBDB0371F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AFD252F-69BF-4756-AA8E-97D62502EC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C5060-3EB4-4F26-B7F8-4A4BC04DB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94422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704800B-0BE0-35E2-BA0B-55914EE5FE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C0C6F04-3A5A-4911-4A61-7AC1B29470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399DEE9-229B-24A2-2482-3BFC958711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FA995-C7D9-4C6C-A9E8-E56122711CA3}" type="datetimeFigureOut">
              <a:rPr lang="zh-CN" altLang="en-US" smtClean="0"/>
              <a:t>2025/5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DEEE791-76F1-E3AE-587E-E16ED4B03C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40C7962-8DE6-D1BF-2105-4C3D390D1A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C5060-3EB4-4F26-B7F8-4A4BC04DB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33852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94E0E96-926E-8A1C-9110-5E0F5F27E7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850EBCA-8C34-E206-AE05-DF3C022FDC4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6ED2EFB-37AC-23E6-3EDB-7ECFB3C74F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8073BC0-0DA0-13C3-B59C-AF415FE0C7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FA995-C7D9-4C6C-A9E8-E56122711CA3}" type="datetimeFigureOut">
              <a:rPr lang="zh-CN" altLang="en-US" smtClean="0"/>
              <a:t>2025/5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C3FEC0C-AC20-021C-C764-EF30832D2E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491F608-0AD3-2115-EB29-1C5515421D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C5060-3EB4-4F26-B7F8-4A4BC04DB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98938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25C93E7-FCCE-B9C4-F802-C428F1AD35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1565C9C-9350-2E9F-688D-745A8B5A2A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C2C2A49-4B03-357A-B9F3-168EB68890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5546A75-9769-B245-300D-B889EF2F87A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D322182-F045-3BAD-58DE-4BE54CF2B42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E9BA6CD6-5C48-9D59-28D2-EFE0F3B8D6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FA995-C7D9-4C6C-A9E8-E56122711CA3}" type="datetimeFigureOut">
              <a:rPr lang="zh-CN" altLang="en-US" smtClean="0"/>
              <a:t>2025/5/2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48CED0C-11F3-C498-C0B0-5281A5A181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4608D991-9CAF-611E-369D-24D7D8DF53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C5060-3EB4-4F26-B7F8-4A4BC04DB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7561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BAE25AC-3795-37F2-B16E-36C5362CD7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EF466A9B-D303-287F-203D-3B50964FD8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FA995-C7D9-4C6C-A9E8-E56122711CA3}" type="datetimeFigureOut">
              <a:rPr lang="zh-CN" altLang="en-US" smtClean="0"/>
              <a:t>2025/5/2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0F11C4E-DE13-FC1C-37C6-E9747F9EB1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EB09CA46-8B52-BB18-3B29-7053C6A036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C5060-3EB4-4F26-B7F8-4A4BC04DB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64125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BCF32AEA-D64B-09D3-D766-76437F5499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FA995-C7D9-4C6C-A9E8-E56122711CA3}" type="datetimeFigureOut">
              <a:rPr lang="zh-CN" altLang="en-US" smtClean="0"/>
              <a:t>2025/5/2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D58B35B-691E-6AFD-731B-1C6D977DE1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5B5D2D8-6ED0-1B41-25F6-A56419A298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C5060-3EB4-4F26-B7F8-4A4BC04DB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73445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29FCE4-8495-FEAE-ED0C-5AE42261C1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9AC8A52-B1CC-390B-0728-4664D91A33B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5546937-7FAE-ED0E-5680-43C4E257CC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2F692DC-928E-B322-43D5-80C411C3A9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FA995-C7D9-4C6C-A9E8-E56122711CA3}" type="datetimeFigureOut">
              <a:rPr lang="zh-CN" altLang="en-US" smtClean="0"/>
              <a:t>2025/5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CD26197-3709-DCC6-B639-0DA00616FD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6E0B652-E8C5-EF6B-E5A8-EA52B7511D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C5060-3EB4-4F26-B7F8-4A4BC04DB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31848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CF688CC-3AFE-5BB9-87EC-25C1A60B71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57D826C5-354E-E0F4-15ED-6F4B7FFA7C9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D028787-2D45-9192-99C7-FA494CEC0C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8A5A8A4-B06E-1A85-1CAF-6C07293BA8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FA995-C7D9-4C6C-A9E8-E56122711CA3}" type="datetimeFigureOut">
              <a:rPr lang="zh-CN" altLang="en-US" smtClean="0"/>
              <a:t>2025/5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6ED0235-EA14-02FE-E3BD-91DC3F9DDB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325D070-A682-4055-CA48-E9D64C6060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C5060-3EB4-4F26-B7F8-4A4BC04DB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258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D8214F8-2E3A-D3D2-9E09-1DA2DC2DF2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47E6020-E527-FF42-C5AA-55718985C7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C93C6EA-ADC9-A53A-CAAB-1A30DA9BDB4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AFA995-C7D9-4C6C-A9E8-E56122711CA3}" type="datetimeFigureOut">
              <a:rPr lang="zh-CN" altLang="en-US" smtClean="0"/>
              <a:t>2025/5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9B4E859-A7F6-670C-5CFC-643FC180407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1DC61AF-2DF8-FDCE-694D-5BC05BE2B3C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2C5060-3EB4-4F26-B7F8-4A4BC04DB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14202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5" name="组合 44">
            <a:extLst>
              <a:ext uri="{FF2B5EF4-FFF2-40B4-BE49-F238E27FC236}">
                <a16:creationId xmlns:a16="http://schemas.microsoft.com/office/drawing/2014/main" id="{B6FDBE3F-3B6A-B634-0305-C4273220845B}"/>
              </a:ext>
            </a:extLst>
          </p:cNvPr>
          <p:cNvGrpSpPr/>
          <p:nvPr/>
        </p:nvGrpSpPr>
        <p:grpSpPr>
          <a:xfrm>
            <a:off x="593716" y="1288752"/>
            <a:ext cx="8251092" cy="3088352"/>
            <a:chOff x="593716" y="1288752"/>
            <a:chExt cx="8251092" cy="3088352"/>
          </a:xfrm>
        </p:grpSpPr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EE836BBB-5D87-6654-4637-72DBCDB1A977}"/>
                </a:ext>
              </a:extLst>
            </p:cNvPr>
            <p:cNvSpPr txBox="1"/>
            <p:nvPr/>
          </p:nvSpPr>
          <p:spPr>
            <a:xfrm>
              <a:off x="2301342" y="1288752"/>
              <a:ext cx="8851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en-US" altLang="zh-CN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O (l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" name="直接箭头连接符 3">
              <a:extLst>
                <a:ext uri="{FF2B5EF4-FFF2-40B4-BE49-F238E27FC236}">
                  <a16:creationId xmlns:a16="http://schemas.microsoft.com/office/drawing/2014/main" id="{93FF90B4-1ED6-7040-7989-5BD1278432B9}"/>
                </a:ext>
              </a:extLst>
            </p:cNvPr>
            <p:cNvCxnSpPr>
              <a:cxnSpLocks/>
              <a:stCxn id="2" idx="2"/>
            </p:cNvCxnSpPr>
            <p:nvPr/>
          </p:nvCxnSpPr>
          <p:spPr>
            <a:xfrm>
              <a:off x="2743932" y="1658084"/>
              <a:ext cx="0" cy="354824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365B8AEE-FD84-B046-0E15-6A14B83F4C54}"/>
                </a:ext>
              </a:extLst>
            </p:cNvPr>
            <p:cNvSpPr txBox="1"/>
            <p:nvPr/>
          </p:nvSpPr>
          <p:spPr>
            <a:xfrm>
              <a:off x="593716" y="1919926"/>
              <a:ext cx="9621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O</a:t>
              </a:r>
              <a:r>
                <a:rPr lang="en-US" altLang="zh-CN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 (g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" name="直接箭头连接符 6">
              <a:extLst>
                <a:ext uri="{FF2B5EF4-FFF2-40B4-BE49-F238E27FC236}">
                  <a16:creationId xmlns:a16="http://schemas.microsoft.com/office/drawing/2014/main" id="{E94574FA-DB3A-3C04-C5E5-843DCFF33CC4}"/>
                </a:ext>
              </a:extLst>
            </p:cNvPr>
            <p:cNvCxnSpPr>
              <a:cxnSpLocks/>
            </p:cNvCxnSpPr>
            <p:nvPr/>
          </p:nvCxnSpPr>
          <p:spPr>
            <a:xfrm>
              <a:off x="1904636" y="2104592"/>
              <a:ext cx="18000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E837F584-557A-8EB7-4543-1AEE3E923D3E}"/>
                </a:ext>
              </a:extLst>
            </p:cNvPr>
            <p:cNvSpPr txBox="1"/>
            <p:nvPr/>
          </p:nvSpPr>
          <p:spPr>
            <a:xfrm>
              <a:off x="4195839" y="1919926"/>
              <a:ext cx="56938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2H</a:t>
              </a:r>
              <a:r>
                <a:rPr lang="en-US" altLang="zh-CN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C3E2EEB4-B557-FF49-13DF-C24C7F7A32CB}"/>
                </a:ext>
              </a:extLst>
            </p:cNvPr>
            <p:cNvSpPr txBox="1"/>
            <p:nvPr/>
          </p:nvSpPr>
          <p:spPr>
            <a:xfrm>
              <a:off x="5151506" y="1919926"/>
              <a:ext cx="3193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16A35D37-6168-9F39-F312-5CFC18E5E09A}"/>
                </a:ext>
              </a:extLst>
            </p:cNvPr>
            <p:cNvSpPr txBox="1"/>
            <p:nvPr/>
          </p:nvSpPr>
          <p:spPr>
            <a:xfrm>
              <a:off x="5857105" y="1919926"/>
              <a:ext cx="75212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O</a:t>
              </a:r>
              <a:r>
                <a:rPr lang="en-US" altLang="zh-CN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altLang="zh-CN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-</a:t>
              </a:r>
              <a:endParaRPr lang="zh-CN" altLang="en-US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" name="直接箭头连接符 17">
              <a:extLst>
                <a:ext uri="{FF2B5EF4-FFF2-40B4-BE49-F238E27FC236}">
                  <a16:creationId xmlns:a16="http://schemas.microsoft.com/office/drawing/2014/main" id="{8456F587-E12A-13A4-475B-D752BD6F3490}"/>
                </a:ext>
              </a:extLst>
            </p:cNvPr>
            <p:cNvCxnSpPr>
              <a:cxnSpLocks/>
            </p:cNvCxnSpPr>
            <p:nvPr/>
          </p:nvCxnSpPr>
          <p:spPr>
            <a:xfrm>
              <a:off x="4430560" y="2424175"/>
              <a:ext cx="0" cy="1129097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4231265A-5AEF-E77B-A97B-311B2A4CE31D}"/>
                </a:ext>
              </a:extLst>
            </p:cNvPr>
            <p:cNvSpPr txBox="1"/>
            <p:nvPr/>
          </p:nvSpPr>
          <p:spPr>
            <a:xfrm>
              <a:off x="2691989" y="2631888"/>
              <a:ext cx="1916250" cy="6463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Polarize</a:t>
              </a:r>
            </a:p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Bond breaking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FE2C9D18-E6BE-BFDF-48AE-3F6A1D1C0248}"/>
                </a:ext>
              </a:extLst>
            </p:cNvPr>
            <p:cNvSpPr txBox="1"/>
            <p:nvPr/>
          </p:nvSpPr>
          <p:spPr>
            <a:xfrm>
              <a:off x="1847104" y="2158700"/>
              <a:ext cx="1857532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Diffuse-Dissolve</a:t>
              </a: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CD1E0AB1-257C-0578-0566-EAF615D97B69}"/>
                </a:ext>
              </a:extLst>
            </p:cNvPr>
            <p:cNvSpPr txBox="1"/>
            <p:nvPr/>
          </p:nvSpPr>
          <p:spPr>
            <a:xfrm>
              <a:off x="3757138" y="3683074"/>
              <a:ext cx="13468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a</a:t>
              </a:r>
              <a:r>
                <a:rPr lang="en-US" altLang="zh-CN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SiO</a:t>
              </a:r>
              <a:r>
                <a:rPr lang="en-US" altLang="zh-CN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(s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" name="直接箭头连接符 30">
              <a:extLst>
                <a:ext uri="{FF2B5EF4-FFF2-40B4-BE49-F238E27FC236}">
                  <a16:creationId xmlns:a16="http://schemas.microsoft.com/office/drawing/2014/main" id="{3E90645C-BB29-F9C4-B803-4ED5A61FB65A}"/>
                </a:ext>
              </a:extLst>
            </p:cNvPr>
            <p:cNvCxnSpPr>
              <a:cxnSpLocks/>
            </p:cNvCxnSpPr>
            <p:nvPr/>
          </p:nvCxnSpPr>
          <p:spPr>
            <a:xfrm>
              <a:off x="5114023" y="3865326"/>
              <a:ext cx="7200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C258D367-9541-04FE-9863-2C3C0DB976EF}"/>
                </a:ext>
              </a:extLst>
            </p:cNvPr>
            <p:cNvSpPr txBox="1"/>
            <p:nvPr/>
          </p:nvSpPr>
          <p:spPr>
            <a:xfrm>
              <a:off x="5905997" y="3680660"/>
              <a:ext cx="6543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a</a:t>
              </a:r>
              <a:r>
                <a:rPr lang="en-US" altLang="zh-CN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+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9BDDE108-9248-928F-3743-7C2FC3688414}"/>
                </a:ext>
              </a:extLst>
            </p:cNvPr>
            <p:cNvSpPr txBox="1"/>
            <p:nvPr/>
          </p:nvSpPr>
          <p:spPr>
            <a:xfrm>
              <a:off x="6888793" y="3688189"/>
              <a:ext cx="3193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012F4728-59F8-E56A-FE45-FC53F5DC8190}"/>
                </a:ext>
              </a:extLst>
            </p:cNvPr>
            <p:cNvSpPr txBox="1"/>
            <p:nvPr/>
          </p:nvSpPr>
          <p:spPr>
            <a:xfrm>
              <a:off x="7485140" y="3688189"/>
              <a:ext cx="13596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SiO</a:t>
              </a:r>
              <a:r>
                <a:rPr lang="en-US" altLang="zh-CN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 gel (s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0F5A04A3-57A0-367E-34AF-E3F05E9BEF16}"/>
                </a:ext>
              </a:extLst>
            </p:cNvPr>
            <p:cNvSpPr txBox="1"/>
            <p:nvPr/>
          </p:nvSpPr>
          <p:spPr>
            <a:xfrm>
              <a:off x="4947688" y="4007772"/>
              <a:ext cx="1066507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Dissolve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9" name="直接箭头连接符 38">
              <a:extLst>
                <a:ext uri="{FF2B5EF4-FFF2-40B4-BE49-F238E27FC236}">
                  <a16:creationId xmlns:a16="http://schemas.microsoft.com/office/drawing/2014/main" id="{863246EC-E946-3754-EAC0-4E26882B6D78}"/>
                </a:ext>
              </a:extLst>
            </p:cNvPr>
            <p:cNvCxnSpPr>
              <a:cxnSpLocks/>
            </p:cNvCxnSpPr>
            <p:nvPr/>
          </p:nvCxnSpPr>
          <p:spPr>
            <a:xfrm>
              <a:off x="6154009" y="2390504"/>
              <a:ext cx="0" cy="1129097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接箭头连接符 39">
              <a:extLst>
                <a:ext uri="{FF2B5EF4-FFF2-40B4-BE49-F238E27FC236}">
                  <a16:creationId xmlns:a16="http://schemas.microsoft.com/office/drawing/2014/main" id="{05B05A67-C1CC-83A0-E499-E574350DDDF4}"/>
                </a:ext>
              </a:extLst>
            </p:cNvPr>
            <p:cNvCxnSpPr>
              <a:cxnSpLocks/>
            </p:cNvCxnSpPr>
            <p:nvPr/>
          </p:nvCxnSpPr>
          <p:spPr>
            <a:xfrm>
              <a:off x="6159661" y="2956087"/>
              <a:ext cx="1345783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7911886A-8E6E-B624-64A8-032AD054CA78}"/>
                </a:ext>
              </a:extLst>
            </p:cNvPr>
            <p:cNvSpPr txBox="1"/>
            <p:nvPr/>
          </p:nvSpPr>
          <p:spPr>
            <a:xfrm>
              <a:off x="6169774" y="2536132"/>
              <a:ext cx="1284473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zh-CN" altLang="en-US" dirty="0">
                  <a:latin typeface="Arial" panose="020B0604020202020204" pitchFamily="34" charset="0"/>
                  <a:cs typeface="Arial" panose="020B0604020202020204" pitchFamily="34" charset="0"/>
                </a:rPr>
                <a:t>recipitate</a:t>
              </a:r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2666A615-BD41-B408-88E7-A62ED6548050}"/>
                </a:ext>
              </a:extLst>
            </p:cNvPr>
            <p:cNvSpPr txBox="1"/>
            <p:nvPr/>
          </p:nvSpPr>
          <p:spPr>
            <a:xfrm>
              <a:off x="7521208" y="2768141"/>
              <a:ext cx="12875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aCO</a:t>
              </a:r>
              <a:r>
                <a:rPr lang="en-US" altLang="zh-CN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 (s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5315211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组合 6">
            <a:extLst>
              <a:ext uri="{FF2B5EF4-FFF2-40B4-BE49-F238E27FC236}">
                <a16:creationId xmlns:a16="http://schemas.microsoft.com/office/drawing/2014/main" id="{0CB07877-BFE2-2183-6F4A-82AEDB86D998}"/>
              </a:ext>
            </a:extLst>
          </p:cNvPr>
          <p:cNvGrpSpPr/>
          <p:nvPr/>
        </p:nvGrpSpPr>
        <p:grpSpPr>
          <a:xfrm>
            <a:off x="590550" y="-189691"/>
            <a:ext cx="11802489" cy="7213061"/>
            <a:chOff x="590550" y="-189691"/>
            <a:chExt cx="11802489" cy="7213061"/>
          </a:xfrm>
        </p:grpSpPr>
        <p:pic>
          <p:nvPicPr>
            <p:cNvPr id="2" name="图片 1">
              <a:extLst>
                <a:ext uri="{FF2B5EF4-FFF2-40B4-BE49-F238E27FC236}">
                  <a16:creationId xmlns:a16="http://schemas.microsoft.com/office/drawing/2014/main" id="{ECEC80B7-6571-835D-6CFF-E2868D4CE2E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8563" r="38998"/>
            <a:stretch/>
          </p:blipFill>
          <p:spPr>
            <a:xfrm>
              <a:off x="7694580" y="-184827"/>
              <a:ext cx="4698459" cy="6858000"/>
            </a:xfrm>
            <a:prstGeom prst="rect">
              <a:avLst/>
            </a:prstGeom>
          </p:spPr>
        </p:pic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910B6CB6-109E-6BF0-97E1-7649F280810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2912" r="11704"/>
            <a:stretch/>
          </p:blipFill>
          <p:spPr>
            <a:xfrm>
              <a:off x="590550" y="-189691"/>
              <a:ext cx="7104030" cy="7213061"/>
            </a:xfrm>
            <a:prstGeom prst="rect">
              <a:avLst/>
            </a:prstGeom>
          </p:spPr>
        </p:pic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D37EA4BB-A271-22D9-9509-919789301FB2}"/>
                </a:ext>
              </a:extLst>
            </p:cNvPr>
            <p:cNvSpPr txBox="1"/>
            <p:nvPr/>
          </p:nvSpPr>
          <p:spPr>
            <a:xfrm>
              <a:off x="711200" y="533400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20FF9583-5822-BAF4-749C-CBDD5013EC7B}"/>
                </a:ext>
              </a:extLst>
            </p:cNvPr>
            <p:cNvSpPr txBox="1"/>
            <p:nvPr/>
          </p:nvSpPr>
          <p:spPr>
            <a:xfrm>
              <a:off x="7531715" y="533400"/>
              <a:ext cx="3257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257263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EDA1EACC-8874-FC3E-C87A-6C32348928B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16053" y="0"/>
            <a:ext cx="8959893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501613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组合 10">
            <a:extLst>
              <a:ext uri="{FF2B5EF4-FFF2-40B4-BE49-F238E27FC236}">
                <a16:creationId xmlns:a16="http://schemas.microsoft.com/office/drawing/2014/main" id="{0EBB19B4-13B5-1D00-FAA2-2164148753A4}"/>
              </a:ext>
            </a:extLst>
          </p:cNvPr>
          <p:cNvGrpSpPr/>
          <p:nvPr/>
        </p:nvGrpSpPr>
        <p:grpSpPr>
          <a:xfrm>
            <a:off x="930252" y="1332706"/>
            <a:ext cx="8646707" cy="3600000"/>
            <a:chOff x="930252" y="1332706"/>
            <a:chExt cx="8646707" cy="3600000"/>
          </a:xfrm>
        </p:grpSpPr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D3B1034C-62E0-6534-75E8-733603A0557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30252" y="1332706"/>
              <a:ext cx="4703356" cy="3600000"/>
            </a:xfrm>
            <a:prstGeom prst="rect">
              <a:avLst/>
            </a:prstGeom>
          </p:spPr>
        </p:pic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ECCCF6DF-7B13-0AFE-41D2-8D7A5CBE16A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873603" y="1332706"/>
              <a:ext cx="4703356" cy="3600000"/>
            </a:xfrm>
            <a:prstGeom prst="rect">
              <a:avLst/>
            </a:prstGeom>
          </p:spPr>
        </p:pic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CF74B31F-3EA6-D1AC-FE9A-109139329B60}"/>
                </a:ext>
              </a:extLst>
            </p:cNvPr>
            <p:cNvSpPr txBox="1"/>
            <p:nvPr/>
          </p:nvSpPr>
          <p:spPr>
            <a:xfrm>
              <a:off x="1238250" y="1574800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9D3A7B9C-BA8B-E2BF-B086-BDC1F0FA46C4}"/>
                </a:ext>
              </a:extLst>
            </p:cNvPr>
            <p:cNvSpPr txBox="1"/>
            <p:nvPr/>
          </p:nvSpPr>
          <p:spPr>
            <a:xfrm>
              <a:off x="5181601" y="1574800"/>
              <a:ext cx="3257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3727549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DD32BAF1-1A07-1913-2D3D-D82DA48085E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53607" y="1000725"/>
            <a:ext cx="5558095" cy="42542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577958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>
            <a:extLst>
              <a:ext uri="{FF2B5EF4-FFF2-40B4-BE49-F238E27FC236}">
                <a16:creationId xmlns:a16="http://schemas.microsoft.com/office/drawing/2014/main" id="{A879538C-9585-0394-DC64-7217B4CB6F93}"/>
              </a:ext>
            </a:extLst>
          </p:cNvPr>
          <p:cNvGrpSpPr/>
          <p:nvPr/>
        </p:nvGrpSpPr>
        <p:grpSpPr>
          <a:xfrm>
            <a:off x="1908503" y="221248"/>
            <a:ext cx="8146484" cy="5803897"/>
            <a:chOff x="1908503" y="221248"/>
            <a:chExt cx="8146484" cy="5803897"/>
          </a:xfrm>
        </p:grpSpPr>
        <p:pic>
          <p:nvPicPr>
            <p:cNvPr id="2" name="图片 1">
              <a:extLst>
                <a:ext uri="{FF2B5EF4-FFF2-40B4-BE49-F238E27FC236}">
                  <a16:creationId xmlns:a16="http://schemas.microsoft.com/office/drawing/2014/main" id="{4D51CEA9-5C02-A414-4B98-E7C8A4B8FB7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821967" y="2785145"/>
              <a:ext cx="4233020" cy="3240000"/>
            </a:xfrm>
            <a:prstGeom prst="rect">
              <a:avLst/>
            </a:prstGeom>
          </p:spPr>
        </p:pic>
        <p:grpSp>
          <p:nvGrpSpPr>
            <p:cNvPr id="10" name="组合 9">
              <a:extLst>
                <a:ext uri="{FF2B5EF4-FFF2-40B4-BE49-F238E27FC236}">
                  <a16:creationId xmlns:a16="http://schemas.microsoft.com/office/drawing/2014/main" id="{B8C99EE2-822E-7104-5E77-92A2DE363D18}"/>
                </a:ext>
              </a:extLst>
            </p:cNvPr>
            <p:cNvGrpSpPr/>
            <p:nvPr/>
          </p:nvGrpSpPr>
          <p:grpSpPr>
            <a:xfrm>
              <a:off x="1908503" y="221248"/>
              <a:ext cx="7759809" cy="5803897"/>
              <a:chOff x="1908503" y="221248"/>
              <a:chExt cx="7759809" cy="5803897"/>
            </a:xfrm>
          </p:grpSpPr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4268BFA7-F83F-BFED-324A-32D6273976A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908503" y="2785145"/>
                <a:ext cx="4233021" cy="3240000"/>
              </a:xfrm>
              <a:prstGeom prst="rect">
                <a:avLst/>
              </a:prstGeom>
            </p:spPr>
          </p:pic>
          <p:pic>
            <p:nvPicPr>
              <p:cNvPr id="6" name="图片 5">
                <a:extLst>
                  <a:ext uri="{FF2B5EF4-FFF2-40B4-BE49-F238E27FC236}">
                    <a16:creationId xmlns:a16="http://schemas.microsoft.com/office/drawing/2014/main" id="{357C53DC-2B01-6115-2117-9D88F9E00EF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491530" y="324213"/>
                <a:ext cx="7176782" cy="2707442"/>
              </a:xfrm>
              <a:prstGeom prst="rect">
                <a:avLst/>
              </a:prstGeom>
            </p:spPr>
          </p:pic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835E87DA-A4A1-58D1-4242-A5929119643F}"/>
                  </a:ext>
                </a:extLst>
              </p:cNvPr>
              <p:cNvSpPr txBox="1"/>
              <p:nvPr/>
            </p:nvSpPr>
            <p:spPr>
              <a:xfrm>
                <a:off x="2157885" y="221248"/>
                <a:ext cx="31290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zh-CN" alt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F667AF57-0D7A-2EED-ACE9-FE1D0527AFA2}"/>
                  </a:ext>
                </a:extLst>
              </p:cNvPr>
              <p:cNvSpPr txBox="1"/>
              <p:nvPr/>
            </p:nvSpPr>
            <p:spPr>
              <a:xfrm>
                <a:off x="2145061" y="2837253"/>
                <a:ext cx="32573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zh-CN" alt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02CC446A-4805-5950-9593-A5087FA6BB2A}"/>
                  </a:ext>
                </a:extLst>
              </p:cNvPr>
              <p:cNvSpPr txBox="1"/>
              <p:nvPr/>
            </p:nvSpPr>
            <p:spPr>
              <a:xfrm>
                <a:off x="5901502" y="2837253"/>
                <a:ext cx="31290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zh-CN" alt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48987869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组合 16">
            <a:extLst>
              <a:ext uri="{FF2B5EF4-FFF2-40B4-BE49-F238E27FC236}">
                <a16:creationId xmlns:a16="http://schemas.microsoft.com/office/drawing/2014/main" id="{73902FD0-2DED-3193-E739-D60F73374010}"/>
              </a:ext>
            </a:extLst>
          </p:cNvPr>
          <p:cNvGrpSpPr/>
          <p:nvPr/>
        </p:nvGrpSpPr>
        <p:grpSpPr>
          <a:xfrm>
            <a:off x="1864640" y="1029418"/>
            <a:ext cx="8191213" cy="4371572"/>
            <a:chOff x="1864640" y="1029418"/>
            <a:chExt cx="8191213" cy="4371572"/>
          </a:xfrm>
        </p:grpSpPr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5D4568B7-40E1-3F1E-4AAF-96C2DD075C8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864640" y="1029418"/>
              <a:ext cx="4091176" cy="2160000"/>
            </a:xfrm>
            <a:prstGeom prst="rect">
              <a:avLst/>
            </a:prstGeom>
          </p:spPr>
        </p:pic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89380EE6-BDBC-3231-59DD-CA1FC6ADC29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011118" y="1029418"/>
              <a:ext cx="4044734" cy="2160000"/>
            </a:xfrm>
            <a:prstGeom prst="rect">
              <a:avLst/>
            </a:prstGeom>
          </p:spPr>
        </p:pic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89E814C7-5810-664A-88BC-76E4EA318DB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864640" y="3240990"/>
              <a:ext cx="4091175" cy="2160000"/>
            </a:xfrm>
            <a:prstGeom prst="rect">
              <a:avLst/>
            </a:prstGeom>
          </p:spPr>
        </p:pic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77B9EBEF-22C0-DDD2-DBA0-514301A6A88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011119" y="3240990"/>
              <a:ext cx="4044734" cy="2160000"/>
            </a:xfrm>
            <a:prstGeom prst="rect">
              <a:avLst/>
            </a:prstGeom>
          </p:spPr>
        </p:pic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926D0EF1-FEEF-D760-8512-8666E1D63A0F}"/>
                </a:ext>
              </a:extLst>
            </p:cNvPr>
            <p:cNvSpPr txBox="1"/>
            <p:nvPr/>
          </p:nvSpPr>
          <p:spPr>
            <a:xfrm>
              <a:off x="1864640" y="1029418"/>
              <a:ext cx="304892" cy="3539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altLang="zh-CN" sz="1700" b="1" kern="100" dirty="0">
                  <a:solidFill>
                    <a:schemeClr val="bg1"/>
                  </a:solidFill>
                  <a:latin typeface="Arial" panose="020B0604020202020204" pitchFamily="34" charset="0"/>
                  <a:ea typeface="Microsoft YaHei UI" panose="020B0503020204020204" pitchFamily="34" charset="-122"/>
                  <a:cs typeface="Arial" panose="020B0604020202020204" pitchFamily="34" charset="0"/>
                </a:rPr>
                <a:t>a</a:t>
              </a:r>
              <a:endParaRPr lang="zh-CN" altLang="en-US" sz="1700" b="1" kern="100" dirty="0">
                <a:solidFill>
                  <a:schemeClr val="bg1"/>
                </a:solidFill>
                <a:latin typeface="Arial" panose="020B0604020202020204" pitchFamily="34" charset="0"/>
                <a:ea typeface="Microsoft YaHei UI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567FF959-C70A-D25B-2130-D210E0C3D95B}"/>
                </a:ext>
              </a:extLst>
            </p:cNvPr>
            <p:cNvSpPr txBox="1"/>
            <p:nvPr/>
          </p:nvSpPr>
          <p:spPr>
            <a:xfrm>
              <a:off x="5995433" y="1029418"/>
              <a:ext cx="317716" cy="3539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altLang="zh-CN" sz="1700" b="1" kern="100" dirty="0">
                  <a:solidFill>
                    <a:schemeClr val="bg1"/>
                  </a:solidFill>
                  <a:latin typeface="Arial" panose="020B0604020202020204" pitchFamily="34" charset="0"/>
                  <a:ea typeface="Microsoft YaHei UI" panose="020B0503020204020204" pitchFamily="34" charset="-122"/>
                  <a:cs typeface="Arial" panose="020B0604020202020204" pitchFamily="34" charset="0"/>
                </a:rPr>
                <a:t>b</a:t>
              </a:r>
              <a:endParaRPr lang="zh-CN" altLang="en-US" sz="1700" b="1" kern="100" dirty="0">
                <a:solidFill>
                  <a:schemeClr val="bg1"/>
                </a:solidFill>
                <a:latin typeface="Arial" panose="020B0604020202020204" pitchFamily="34" charset="0"/>
                <a:ea typeface="Microsoft YaHei UI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D1103F0B-5CFA-AD8A-D83F-1125A134CAAB}"/>
                </a:ext>
              </a:extLst>
            </p:cNvPr>
            <p:cNvSpPr txBox="1"/>
            <p:nvPr/>
          </p:nvSpPr>
          <p:spPr>
            <a:xfrm>
              <a:off x="1864640" y="3240990"/>
              <a:ext cx="304892" cy="3539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altLang="zh-CN" sz="1700" b="1" kern="100" dirty="0">
                  <a:solidFill>
                    <a:schemeClr val="bg1"/>
                  </a:solidFill>
                  <a:latin typeface="Arial" panose="020B0604020202020204" pitchFamily="34" charset="0"/>
                  <a:ea typeface="Microsoft YaHei UI" panose="020B0503020204020204" pitchFamily="34" charset="-122"/>
                  <a:cs typeface="Arial" panose="020B0604020202020204" pitchFamily="34" charset="0"/>
                </a:rPr>
                <a:t>c</a:t>
              </a:r>
              <a:endParaRPr lang="zh-CN" altLang="en-US" sz="1700" b="1" kern="100" dirty="0">
                <a:solidFill>
                  <a:schemeClr val="bg1"/>
                </a:solidFill>
                <a:latin typeface="Arial" panose="020B0604020202020204" pitchFamily="34" charset="0"/>
                <a:ea typeface="Microsoft YaHei UI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16E07C49-1A33-16A2-485E-27C46B790EBB}"/>
                </a:ext>
              </a:extLst>
            </p:cNvPr>
            <p:cNvSpPr txBox="1"/>
            <p:nvPr/>
          </p:nvSpPr>
          <p:spPr>
            <a:xfrm>
              <a:off x="6011118" y="3240990"/>
              <a:ext cx="317716" cy="3539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altLang="zh-CN" sz="1700" b="1" kern="100" dirty="0">
                  <a:solidFill>
                    <a:schemeClr val="bg1"/>
                  </a:solidFill>
                  <a:latin typeface="Arial" panose="020B0604020202020204" pitchFamily="34" charset="0"/>
                  <a:ea typeface="Microsoft YaHei UI" panose="020B0503020204020204" pitchFamily="34" charset="-122"/>
                  <a:cs typeface="Arial" panose="020B0604020202020204" pitchFamily="34" charset="0"/>
                </a:rPr>
                <a:t>d</a:t>
              </a:r>
              <a:endParaRPr lang="zh-CN" altLang="en-US" sz="1700" b="1" kern="100" dirty="0">
                <a:solidFill>
                  <a:schemeClr val="bg1"/>
                </a:solidFill>
                <a:latin typeface="Arial" panose="020B0604020202020204" pitchFamily="34" charset="0"/>
                <a:ea typeface="Microsoft YaHei UI" panose="020B0503020204020204" pitchFamily="34" charset="-122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966377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46</Words>
  <Application>Microsoft Office PowerPoint</Application>
  <PresentationFormat>宽屏</PresentationFormat>
  <Paragraphs>26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1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靖泽 陈</dc:creator>
  <cp:lastModifiedBy>靖泽 陈</cp:lastModifiedBy>
  <cp:revision>2</cp:revision>
  <dcterms:created xsi:type="dcterms:W3CDTF">2025-05-26T01:24:30Z</dcterms:created>
  <dcterms:modified xsi:type="dcterms:W3CDTF">2025-05-29T03:47:00Z</dcterms:modified>
</cp:coreProperties>
</file>